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4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04661AE-7DF0-C154-7593-33366B339F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595" y="66764"/>
            <a:ext cx="11924810" cy="672447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33FC216-5037-2241-AAE8-163CB5C16969}"/>
              </a:ext>
            </a:extLst>
          </p:cNvPr>
          <p:cNvSpPr txBox="1"/>
          <p:nvPr/>
        </p:nvSpPr>
        <p:spPr>
          <a:xfrm>
            <a:off x="7744968" y="2130778"/>
            <a:ext cx="4191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figure 3. A) TspGW1 </a:t>
            </a:r>
          </a:p>
          <a:p>
            <a:r>
              <a:rPr lang="en-US" sz="1600" dirty="0"/>
              <a:t>digestion assay shows sample containing SNP </a:t>
            </a:r>
          </a:p>
          <a:p>
            <a:r>
              <a:rPr lang="en-US" sz="1600" dirty="0"/>
              <a:t>with one band  (217bp) and two bands  (155/132bp) for wild type allele. B) CDK2A (p16) and C) GAN (</a:t>
            </a:r>
            <a:r>
              <a:rPr lang="en-US" sz="1600" dirty="0" err="1"/>
              <a:t>gigaxonin</a:t>
            </a:r>
            <a:r>
              <a:rPr lang="en-US" sz="1600" dirty="0"/>
              <a:t>) expression in cervical and head and neck cancer cell lines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FDF9C15-1194-B09D-C096-8C05DAE2A4D1}"/>
              </a:ext>
            </a:extLst>
          </p:cNvPr>
          <p:cNvSpPr/>
          <p:nvPr/>
        </p:nvSpPr>
        <p:spPr>
          <a:xfrm>
            <a:off x="256032" y="3108960"/>
            <a:ext cx="2304288" cy="3200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699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2</cp:revision>
  <dcterms:created xsi:type="dcterms:W3CDTF">2024-02-09T21:19:49Z</dcterms:created>
  <dcterms:modified xsi:type="dcterms:W3CDTF">2024-02-09T21:30:07Z</dcterms:modified>
</cp:coreProperties>
</file>